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8288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65"/>
  </p:normalViewPr>
  <p:slideViewPr>
    <p:cSldViewPr snapToGrid="0">
      <p:cViewPr varScale="1">
        <p:scale>
          <a:sx n="44" d="100"/>
          <a:sy n="44" d="100"/>
        </p:scale>
        <p:origin x="1824" y="23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953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453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510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89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389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488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370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076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199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548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266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9E996-4890-438E-9FD7-50018397BBF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86287-EB65-4800-88D6-77AE2FEE998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749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0865" y="511373"/>
            <a:ext cx="8483193" cy="64008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023" y="511373"/>
            <a:ext cx="8329574" cy="64008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64023" y="511373"/>
            <a:ext cx="133171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YT-h vs YT-y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200865" y="511373"/>
            <a:ext cx="128201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YT-y vs YT-f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3455" y="7035027"/>
            <a:ext cx="7844002" cy="595747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420202" y="7665075"/>
            <a:ext cx="129644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YT-f vs YT-p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CCBA195A-A280-F67F-9803-C2EDECE2FB01}"/>
              </a:ext>
            </a:extLst>
          </p:cNvPr>
          <p:cNvSpPr txBox="1"/>
          <p:nvPr/>
        </p:nvSpPr>
        <p:spPr>
          <a:xfrm>
            <a:off x="2123768" y="12991999"/>
            <a:ext cx="15338322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. Classification of KEGG pathways to which the DEGs in YT-h vs YT-y, RT-y vs RT-f, and YT-f vs YT-p were enriched. </a:t>
            </a:r>
            <a:endParaRPr lang="fr-FR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2729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37</Words>
  <Application>Microsoft Macintosh PowerPoint</Application>
  <PresentationFormat>Personnalisé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office</cp:lastModifiedBy>
  <cp:revision>4</cp:revision>
  <dcterms:created xsi:type="dcterms:W3CDTF">2023-03-26T19:23:43Z</dcterms:created>
  <dcterms:modified xsi:type="dcterms:W3CDTF">2023-05-29T14:02:33Z</dcterms:modified>
</cp:coreProperties>
</file>